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72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C05462-A634-4346-AC05-C0564DAE91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34CE79-A5C7-435E-B1F6-C95AE8B2FA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565746-1190-45A8-AECD-95783D33B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433D5B-9951-4EB2-ACC9-67084C400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DDC7C6-7777-4A7E-9444-2BCD82606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69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7F6B9C-D9F6-4A98-90F5-C4D14D3F2B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59AE55-2531-413A-9618-EE4EF8D6BF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E0D8D9-A0EF-416D-A129-5D1289C3C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B5CEF0-F476-44A5-B19F-C1646FA52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C9F132-9845-46F2-BBCA-377C14303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504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88383D3-C0AB-4FC8-8167-386100EA1A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43C1C8-36B0-489C-B93F-7BF11AAD9A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C66863-8E4D-4B78-A5A4-484245D83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0CCA32-6F94-4CF3-8C4E-F0503C9E2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74255B-E112-40C9-AA4D-AEA0506B59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540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FE72B4-B167-4C30-BFC0-38FB4D55E5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C0D4B8-02FF-495C-9E52-B3EB1CA352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A27AAF-C150-4F04-9917-A5F243B91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3AB1E4-062C-4183-986C-C35BF2C92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790028-6FA7-40E8-AE19-FDB8B5CCC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990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A2E29-7469-49AF-8FEB-EC489760AE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950226-5A7E-4D58-8D83-97C8185149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BD4342-18D5-4809-856B-13B940E00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62571E-AF9B-49B9-980B-28E68F398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BEA4F3-39B7-44BD-AF5C-AB33EC1E77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874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95A07-F711-47EA-9C88-B502A013C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652CCB-8B72-4F50-8443-9A086E48FF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87B83F-0151-4496-A6A0-82E6053C2B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EE437C-1818-42DA-AAC8-E61E42BEE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522522-41C0-471A-B44D-DFB74B40D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A22291-28AC-4F4B-A5B2-D8800E370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516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4117FE-7184-48C6-8740-BE960ED0D4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368CFA-CD45-49E2-ABFD-63BD349FC8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9DB3C3-B3F5-4594-82D2-9F24BD4EE2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58CE5E-9A8A-433E-9036-29F4275133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A8FBE0-273B-4462-A0C9-42BF217E3C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61BF194-7AC6-4023-9AF9-E1995E90F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7E89E2-5CEC-4416-A67D-939D18113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09DB0E5-123D-44D5-9000-840CFE3B1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25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568827-1050-4E86-A7D8-E5A313B063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0C54F0-7202-4B58-980B-7829B6700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8E5946A-3333-425C-A446-7F3264FE4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C09115-A6AF-4EB7-A54C-8F14C3D335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93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5F70086-5973-40D7-BD9B-E9785C58A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A34F64A-DEA5-469D-85B2-9F1FD2061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D92E7B-F770-4AA4-AC0A-C1A6F3828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766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ED743-094C-4DAC-ADD7-BDE71E1359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50F2E6-71E1-45C3-BD86-FD13241624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057894D-A08D-4EA7-B5F7-23953351A6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C95076-53AD-4EC2-BACA-21D5F9380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EB15BE-9C36-4305-B68D-CA9A39467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08E9A6-7EEC-494E-854F-77882BBFA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228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7D93C4-3E14-43FC-91FF-E0382B60F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78114C-E4D9-44BC-AAE7-E0EAAD847F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FCEBBA-B9C8-4F11-B27C-4FBD43D895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4D8CEA-0D67-4CA2-9757-FF692FA25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43A2D3-D891-4AF7-A3C8-72FD66184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EBDF9E-A1D9-432C-8B29-319BF65AAE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261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9268533-D251-49E6-82FF-693237E155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654472-9B3F-4F60-8593-74BA9B0E45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FDF515-E64C-429E-9EA3-E234C93E50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D80BB1-1807-4388-AC07-6B41AF301F60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1BF66A-AD97-4B1E-8194-197E3D5BCD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1B4227-E64F-4144-85C9-B9B5A65657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5B121C-1EB3-40EF-83C2-816657716C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724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D7FD5A3-1AF2-4760-814C-E277E3A121A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04" t="25480" r="3230" b="43004"/>
          <a:stretch/>
        </p:blipFill>
        <p:spPr>
          <a:xfrm>
            <a:off x="5455479" y="850900"/>
            <a:ext cx="2819610" cy="939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9801935-36A6-4240-ABC8-8E9891D8505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11" t="24200" b="39603"/>
          <a:stretch/>
        </p:blipFill>
        <p:spPr>
          <a:xfrm>
            <a:off x="660400" y="711200"/>
            <a:ext cx="2952029" cy="10795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A6E61C7-9D9F-44EA-A5DE-2D965EA510D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16" t="24442" r="7875" b="37229"/>
          <a:stretch/>
        </p:blipFill>
        <p:spPr>
          <a:xfrm>
            <a:off x="5455479" y="2006601"/>
            <a:ext cx="3009900" cy="114300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DEC2EA2-CA21-4619-88F3-5895FC5EF78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56" t="22321" r="13455" b="55961"/>
          <a:stretch/>
        </p:blipFill>
        <p:spPr>
          <a:xfrm>
            <a:off x="834664" y="2501900"/>
            <a:ext cx="2603500" cy="64770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CE64716-666F-4A1B-95AB-B9F6EBCBF81A}"/>
              </a:ext>
            </a:extLst>
          </p:cNvPr>
          <p:cNvSpPr txBox="1"/>
          <p:nvPr/>
        </p:nvSpPr>
        <p:spPr>
          <a:xfrm>
            <a:off x="1526110" y="573901"/>
            <a:ext cx="9815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xperiment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F3F0D79-D1CC-4EAE-B213-C1A34B8B9557}"/>
              </a:ext>
            </a:extLst>
          </p:cNvPr>
          <p:cNvSpPr txBox="1"/>
          <p:nvPr/>
        </p:nvSpPr>
        <p:spPr>
          <a:xfrm>
            <a:off x="629570" y="573901"/>
            <a:ext cx="9815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xperiment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E261508-74DE-4B66-A5AE-CD443C4C87EE}"/>
              </a:ext>
            </a:extLst>
          </p:cNvPr>
          <p:cNvSpPr txBox="1"/>
          <p:nvPr/>
        </p:nvSpPr>
        <p:spPr>
          <a:xfrm>
            <a:off x="1401732" y="83551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1DECEDA-48C8-4411-8F5B-EBE2604AD9CF}"/>
              </a:ext>
            </a:extLst>
          </p:cNvPr>
          <p:cNvSpPr txBox="1"/>
          <p:nvPr/>
        </p:nvSpPr>
        <p:spPr>
          <a:xfrm>
            <a:off x="1231651" y="83551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A380453-8FA0-467A-93E2-B1AB7739BC60}"/>
              </a:ext>
            </a:extLst>
          </p:cNvPr>
          <p:cNvSpPr txBox="1"/>
          <p:nvPr/>
        </p:nvSpPr>
        <p:spPr>
          <a:xfrm>
            <a:off x="1052987" y="83551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8FAB0F3-9D97-4BCF-B1F0-08147DEB1523}"/>
              </a:ext>
            </a:extLst>
          </p:cNvPr>
          <p:cNvSpPr txBox="1"/>
          <p:nvPr/>
        </p:nvSpPr>
        <p:spPr>
          <a:xfrm>
            <a:off x="840296" y="84203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15" name="ZoneTexte 70">
            <a:extLst>
              <a:ext uri="{FF2B5EF4-FFF2-40B4-BE49-F238E27FC236}">
                <a16:creationId xmlns:a16="http://schemas.microsoft.com/office/drawing/2014/main" id="{313E2358-2A9C-4AE1-B7AE-363FB2B4B0BB}"/>
              </a:ext>
            </a:extLst>
          </p:cNvPr>
          <p:cNvSpPr txBox="1"/>
          <p:nvPr/>
        </p:nvSpPr>
        <p:spPr>
          <a:xfrm>
            <a:off x="9153023" y="1197422"/>
            <a:ext cx="240405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Human </a:t>
            </a:r>
            <a:r>
              <a:rPr lang="fr-FR" sz="1400" dirty="0" err="1"/>
              <a:t>fibroblasts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control1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Control 2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Patient M01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>
                <a:solidFill>
                  <a:srgbClr val="FF0000"/>
                </a:solidFill>
              </a:rPr>
              <a:t>Patient X not in the </a:t>
            </a:r>
            <a:r>
              <a:rPr lang="fr-FR" sz="1400" dirty="0" err="1">
                <a:solidFill>
                  <a:srgbClr val="FF0000"/>
                </a:solidFill>
              </a:rPr>
              <a:t>paper</a:t>
            </a:r>
            <a:endParaRPr lang="fr-FR" sz="1400" dirty="0">
              <a:solidFill>
                <a:srgbClr val="FF0000"/>
              </a:solidFill>
            </a:endParaRPr>
          </a:p>
          <a:p>
            <a:endParaRPr lang="fr-FR"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F17DA41-DC2E-40A6-B7FC-B844DAB66CE8}"/>
              </a:ext>
            </a:extLst>
          </p:cNvPr>
          <p:cNvSpPr txBox="1"/>
          <p:nvPr/>
        </p:nvSpPr>
        <p:spPr>
          <a:xfrm>
            <a:off x="-36494" y="1044066"/>
            <a:ext cx="817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dr4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8D02A17-A294-4F1C-BCBB-4DA63352A4AA}"/>
              </a:ext>
            </a:extLst>
          </p:cNvPr>
          <p:cNvSpPr txBox="1"/>
          <p:nvPr/>
        </p:nvSpPr>
        <p:spPr>
          <a:xfrm>
            <a:off x="0" y="2549126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Gapdh</a:t>
            </a:r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DAA42F9-8253-4743-B7D5-FD9923C994B7}"/>
              </a:ext>
            </a:extLst>
          </p:cNvPr>
          <p:cNvSpPr/>
          <p:nvPr/>
        </p:nvSpPr>
        <p:spPr>
          <a:xfrm>
            <a:off x="2688821" y="2711930"/>
            <a:ext cx="584201" cy="1805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6FBE20CC-D870-475A-9BD9-1D23961A29C8}"/>
              </a:ext>
            </a:extLst>
          </p:cNvPr>
          <p:cNvCxnSpPr/>
          <p:nvPr/>
        </p:nvCxnSpPr>
        <p:spPr>
          <a:xfrm>
            <a:off x="2456121" y="850900"/>
            <a:ext cx="68024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F806B0A-9B28-479A-8694-A432002846C8}"/>
              </a:ext>
            </a:extLst>
          </p:cNvPr>
          <p:cNvCxnSpPr/>
          <p:nvPr/>
        </p:nvCxnSpPr>
        <p:spPr>
          <a:xfrm>
            <a:off x="1695694" y="850900"/>
            <a:ext cx="68024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A9D0F5E-DFF5-485D-91A9-86C2591E7AFE}"/>
              </a:ext>
            </a:extLst>
          </p:cNvPr>
          <p:cNvCxnSpPr/>
          <p:nvPr/>
        </p:nvCxnSpPr>
        <p:spPr>
          <a:xfrm>
            <a:off x="920555" y="850900"/>
            <a:ext cx="68024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BD2C6FD-305A-42A7-A8A2-2A213686EF93}"/>
              </a:ext>
            </a:extLst>
          </p:cNvPr>
          <p:cNvCxnSpPr/>
          <p:nvPr/>
        </p:nvCxnSpPr>
        <p:spPr>
          <a:xfrm>
            <a:off x="7290395" y="850900"/>
            <a:ext cx="68024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9F53B20-EABB-46A8-8AF2-B5A0915764F2}"/>
              </a:ext>
            </a:extLst>
          </p:cNvPr>
          <p:cNvCxnSpPr/>
          <p:nvPr/>
        </p:nvCxnSpPr>
        <p:spPr>
          <a:xfrm>
            <a:off x="6489409" y="850900"/>
            <a:ext cx="68024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F8002C3C-5BB0-47EF-8524-12184E21FBF0}"/>
              </a:ext>
            </a:extLst>
          </p:cNvPr>
          <p:cNvCxnSpPr/>
          <p:nvPr/>
        </p:nvCxnSpPr>
        <p:spPr>
          <a:xfrm>
            <a:off x="5699014" y="850900"/>
            <a:ext cx="68024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FF8D4838-A6C5-4409-811E-D8BE67020BD6}"/>
              </a:ext>
            </a:extLst>
          </p:cNvPr>
          <p:cNvSpPr txBox="1"/>
          <p:nvPr/>
        </p:nvSpPr>
        <p:spPr>
          <a:xfrm>
            <a:off x="2370306" y="572700"/>
            <a:ext cx="9815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xperiment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20386CE-6BE9-4B65-83B9-F89E314F89F8}"/>
              </a:ext>
            </a:extLst>
          </p:cNvPr>
          <p:cNvSpPr txBox="1"/>
          <p:nvPr/>
        </p:nvSpPr>
        <p:spPr>
          <a:xfrm>
            <a:off x="6352019" y="565037"/>
            <a:ext cx="9815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xperiment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33758D0-0BB1-4B70-8D37-99A3847A50FA}"/>
              </a:ext>
            </a:extLst>
          </p:cNvPr>
          <p:cNvSpPr txBox="1"/>
          <p:nvPr/>
        </p:nvSpPr>
        <p:spPr>
          <a:xfrm>
            <a:off x="5455479" y="565037"/>
            <a:ext cx="9815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xperiment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AE4BE53-CF68-4CC1-B67F-FB1FB4174647}"/>
              </a:ext>
            </a:extLst>
          </p:cNvPr>
          <p:cNvSpPr txBox="1"/>
          <p:nvPr/>
        </p:nvSpPr>
        <p:spPr>
          <a:xfrm>
            <a:off x="7196215" y="563836"/>
            <a:ext cx="9815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xperiment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5AD822B-081D-4328-A87C-82FF14CD2217}"/>
              </a:ext>
            </a:extLst>
          </p:cNvPr>
          <p:cNvSpPr txBox="1"/>
          <p:nvPr/>
        </p:nvSpPr>
        <p:spPr>
          <a:xfrm>
            <a:off x="4642057" y="1129412"/>
            <a:ext cx="817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dr4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7F3AFBA-3E12-47C7-989A-DD17CA628BFB}"/>
              </a:ext>
            </a:extLst>
          </p:cNvPr>
          <p:cNvSpPr txBox="1"/>
          <p:nvPr/>
        </p:nvSpPr>
        <p:spPr>
          <a:xfrm>
            <a:off x="4648848" y="2132568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Gapdh</a:t>
            </a:r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A6348CC-1E7C-4D91-A80A-B6D5E09FB28C}"/>
              </a:ext>
            </a:extLst>
          </p:cNvPr>
          <p:cNvSpPr txBox="1"/>
          <p:nvPr/>
        </p:nvSpPr>
        <p:spPr>
          <a:xfrm>
            <a:off x="2996443" y="801532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19C78B7-C480-4CDA-9633-97E2B7FED0E4}"/>
              </a:ext>
            </a:extLst>
          </p:cNvPr>
          <p:cNvSpPr txBox="1"/>
          <p:nvPr/>
        </p:nvSpPr>
        <p:spPr>
          <a:xfrm>
            <a:off x="2795366" y="813899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31569D8-A69C-4A92-962E-E81E04FCDE02}"/>
              </a:ext>
            </a:extLst>
          </p:cNvPr>
          <p:cNvSpPr txBox="1"/>
          <p:nvPr/>
        </p:nvSpPr>
        <p:spPr>
          <a:xfrm>
            <a:off x="2602273" y="82163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436CC40-C416-44C3-86E0-2AED8025A412}"/>
              </a:ext>
            </a:extLst>
          </p:cNvPr>
          <p:cNvSpPr txBox="1"/>
          <p:nvPr/>
        </p:nvSpPr>
        <p:spPr>
          <a:xfrm>
            <a:off x="2412783" y="82892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3D351651-C762-4B52-B85A-CD25C099D170}"/>
              </a:ext>
            </a:extLst>
          </p:cNvPr>
          <p:cNvSpPr/>
          <p:nvPr/>
        </p:nvSpPr>
        <p:spPr>
          <a:xfrm>
            <a:off x="2631594" y="1090933"/>
            <a:ext cx="584201" cy="1805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F447FEF-890F-4CBA-AF17-682A67D2B587}"/>
              </a:ext>
            </a:extLst>
          </p:cNvPr>
          <p:cNvSpPr txBox="1"/>
          <p:nvPr/>
        </p:nvSpPr>
        <p:spPr>
          <a:xfrm>
            <a:off x="7716123" y="852064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07065C4-7DDE-4256-970E-AC682C600816}"/>
              </a:ext>
            </a:extLst>
          </p:cNvPr>
          <p:cNvSpPr txBox="1"/>
          <p:nvPr/>
        </p:nvSpPr>
        <p:spPr>
          <a:xfrm>
            <a:off x="7578104" y="844574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65B1A25-D9D0-4B04-8759-E7A6F60FA097}"/>
              </a:ext>
            </a:extLst>
          </p:cNvPr>
          <p:cNvSpPr txBox="1"/>
          <p:nvPr/>
        </p:nvSpPr>
        <p:spPr>
          <a:xfrm>
            <a:off x="7417589" y="852063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09BECC7-0E60-439B-9A5D-677383C9A8A8}"/>
              </a:ext>
            </a:extLst>
          </p:cNvPr>
          <p:cNvSpPr txBox="1"/>
          <p:nvPr/>
        </p:nvSpPr>
        <p:spPr>
          <a:xfrm>
            <a:off x="7194006" y="852062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D56E315F-0C96-45A4-81C7-CFCFFAA2A801}"/>
              </a:ext>
            </a:extLst>
          </p:cNvPr>
          <p:cNvSpPr/>
          <p:nvPr/>
        </p:nvSpPr>
        <p:spPr>
          <a:xfrm>
            <a:off x="7424022" y="1181206"/>
            <a:ext cx="584201" cy="1805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C7D360C-D65E-40FA-AA6F-E1345DBC8DD3}"/>
              </a:ext>
            </a:extLst>
          </p:cNvPr>
          <p:cNvSpPr txBox="1"/>
          <p:nvPr/>
        </p:nvSpPr>
        <p:spPr>
          <a:xfrm>
            <a:off x="6992819" y="848488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EB0AB3B-4362-4426-9271-8EFF23D16D79}"/>
              </a:ext>
            </a:extLst>
          </p:cNvPr>
          <p:cNvSpPr txBox="1"/>
          <p:nvPr/>
        </p:nvSpPr>
        <p:spPr>
          <a:xfrm>
            <a:off x="6802354" y="84848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F47D748-6C6E-4EE6-A598-679BBBE78964}"/>
              </a:ext>
            </a:extLst>
          </p:cNvPr>
          <p:cNvSpPr txBox="1"/>
          <p:nvPr/>
        </p:nvSpPr>
        <p:spPr>
          <a:xfrm>
            <a:off x="6623131" y="84848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7C62580-A2CC-4ECA-87A4-5E722C3DDECA}"/>
              </a:ext>
            </a:extLst>
          </p:cNvPr>
          <p:cNvSpPr txBox="1"/>
          <p:nvPr/>
        </p:nvSpPr>
        <p:spPr>
          <a:xfrm>
            <a:off x="6443908" y="855592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9F4D27F-5F24-4846-9044-DE83277ABED0}"/>
              </a:ext>
            </a:extLst>
          </p:cNvPr>
          <p:cNvSpPr txBox="1"/>
          <p:nvPr/>
        </p:nvSpPr>
        <p:spPr>
          <a:xfrm>
            <a:off x="6201737" y="85970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ABCCA4D-947C-4BC5-A57E-67818A032228}"/>
              </a:ext>
            </a:extLst>
          </p:cNvPr>
          <p:cNvSpPr txBox="1"/>
          <p:nvPr/>
        </p:nvSpPr>
        <p:spPr>
          <a:xfrm>
            <a:off x="6011813" y="857364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FAD784C-7C83-4E26-98DE-D6B7F049A468}"/>
              </a:ext>
            </a:extLst>
          </p:cNvPr>
          <p:cNvSpPr txBox="1"/>
          <p:nvPr/>
        </p:nvSpPr>
        <p:spPr>
          <a:xfrm>
            <a:off x="5821474" y="86934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CB49C65-3D34-4C0D-A3D4-7236F31D16D3}"/>
              </a:ext>
            </a:extLst>
          </p:cNvPr>
          <p:cNvSpPr txBox="1"/>
          <p:nvPr/>
        </p:nvSpPr>
        <p:spPr>
          <a:xfrm>
            <a:off x="5619937" y="88964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1A48204-0131-4B6D-A304-F08B7C66085B}"/>
              </a:ext>
            </a:extLst>
          </p:cNvPr>
          <p:cNvSpPr txBox="1"/>
          <p:nvPr/>
        </p:nvSpPr>
        <p:spPr>
          <a:xfrm>
            <a:off x="2200219" y="828924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EF2F7D9-CB3C-4E44-A4D0-B261CD57D4C0}"/>
              </a:ext>
            </a:extLst>
          </p:cNvPr>
          <p:cNvSpPr txBox="1"/>
          <p:nvPr/>
        </p:nvSpPr>
        <p:spPr>
          <a:xfrm>
            <a:off x="2010714" y="839912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B3D813B-8EDA-43CF-9087-EB42D594D9CA}"/>
              </a:ext>
            </a:extLst>
          </p:cNvPr>
          <p:cNvSpPr txBox="1"/>
          <p:nvPr/>
        </p:nvSpPr>
        <p:spPr>
          <a:xfrm>
            <a:off x="1809637" y="839912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468966C-39F2-4588-8FCC-09155A080A3C}"/>
              </a:ext>
            </a:extLst>
          </p:cNvPr>
          <p:cNvSpPr txBox="1"/>
          <p:nvPr/>
        </p:nvSpPr>
        <p:spPr>
          <a:xfrm>
            <a:off x="1609851" y="839912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B1BAB8A9-DD25-4705-AB2A-D90CF40AAE96}"/>
              </a:ext>
            </a:extLst>
          </p:cNvPr>
          <p:cNvSpPr/>
          <p:nvPr/>
        </p:nvSpPr>
        <p:spPr>
          <a:xfrm>
            <a:off x="7470044" y="2157658"/>
            <a:ext cx="584201" cy="1805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F9B7B75-135F-4549-B7BE-10151F8D2AD9}"/>
              </a:ext>
            </a:extLst>
          </p:cNvPr>
          <p:cNvSpPr txBox="1"/>
          <p:nvPr/>
        </p:nvSpPr>
        <p:spPr>
          <a:xfrm>
            <a:off x="2215065" y="4356101"/>
            <a:ext cx="643208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Images were rotated while preparing the figure to start with the WT sample</a:t>
            </a:r>
          </a:p>
          <a:p>
            <a:endParaRPr lang="en-US" sz="1600" dirty="0"/>
          </a:p>
          <a:p>
            <a:r>
              <a:rPr lang="en-US" sz="1600" dirty="0"/>
              <a:t>Rectangle shows the cropped area used in the figure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B2D1D31-6AA0-43CD-AED5-426636AAB381}"/>
              </a:ext>
            </a:extLst>
          </p:cNvPr>
          <p:cNvSpPr txBox="1"/>
          <p:nvPr/>
        </p:nvSpPr>
        <p:spPr>
          <a:xfrm>
            <a:off x="378496" y="110509"/>
            <a:ext cx="1889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2  </a:t>
            </a:r>
            <a:r>
              <a:rPr lang="en-US" b="1"/>
              <a:t>PANEL E</a:t>
            </a:r>
            <a:endParaRPr lang="en-US" b="1" dirty="0"/>
          </a:p>
        </p:txBody>
      </p:sp>
      <p:sp>
        <p:nvSpPr>
          <p:cNvPr id="57" name="ZoneTexte 8">
            <a:extLst>
              <a:ext uri="{FF2B5EF4-FFF2-40B4-BE49-F238E27FC236}">
                <a16:creationId xmlns:a16="http://schemas.microsoft.com/office/drawing/2014/main" id="{2941C3B7-4F66-474A-AAA1-B726B91D61FA}"/>
              </a:ext>
            </a:extLst>
          </p:cNvPr>
          <p:cNvSpPr txBox="1"/>
          <p:nvPr/>
        </p:nvSpPr>
        <p:spPr>
          <a:xfrm>
            <a:off x="3174366" y="895526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58" name="ZoneTexte 9">
            <a:extLst>
              <a:ext uri="{FF2B5EF4-FFF2-40B4-BE49-F238E27FC236}">
                <a16:creationId xmlns:a16="http://schemas.microsoft.com/office/drawing/2014/main" id="{1C260229-D2CA-4291-82A2-132C69599FA4}"/>
              </a:ext>
            </a:extLst>
          </p:cNvPr>
          <p:cNvSpPr txBox="1"/>
          <p:nvPr/>
        </p:nvSpPr>
        <p:spPr>
          <a:xfrm>
            <a:off x="3174366" y="1024269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59" name="ZoneTexte 11">
            <a:extLst>
              <a:ext uri="{FF2B5EF4-FFF2-40B4-BE49-F238E27FC236}">
                <a16:creationId xmlns:a16="http://schemas.microsoft.com/office/drawing/2014/main" id="{BB1B1CEA-3648-402C-AC55-738CC0614D9E}"/>
              </a:ext>
            </a:extLst>
          </p:cNvPr>
          <p:cNvSpPr txBox="1"/>
          <p:nvPr/>
        </p:nvSpPr>
        <p:spPr>
          <a:xfrm>
            <a:off x="3187600" y="1144772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60" name="ZoneTexte 14">
            <a:extLst>
              <a:ext uri="{FF2B5EF4-FFF2-40B4-BE49-F238E27FC236}">
                <a16:creationId xmlns:a16="http://schemas.microsoft.com/office/drawing/2014/main" id="{1260D0FD-C872-49FE-A052-A6FAB73DBE8E}"/>
              </a:ext>
            </a:extLst>
          </p:cNvPr>
          <p:cNvSpPr txBox="1"/>
          <p:nvPr/>
        </p:nvSpPr>
        <p:spPr>
          <a:xfrm>
            <a:off x="3254747" y="257069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61" name="ZoneTexte 15">
            <a:extLst>
              <a:ext uri="{FF2B5EF4-FFF2-40B4-BE49-F238E27FC236}">
                <a16:creationId xmlns:a16="http://schemas.microsoft.com/office/drawing/2014/main" id="{FBB14CA8-BBBB-4283-A530-2E5AE2F1CB7A}"/>
              </a:ext>
            </a:extLst>
          </p:cNvPr>
          <p:cNvSpPr txBox="1"/>
          <p:nvPr/>
        </p:nvSpPr>
        <p:spPr>
          <a:xfrm>
            <a:off x="3260450" y="2821338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sp>
        <p:nvSpPr>
          <p:cNvPr id="62" name="ZoneTexte 8">
            <a:extLst>
              <a:ext uri="{FF2B5EF4-FFF2-40B4-BE49-F238E27FC236}">
                <a16:creationId xmlns:a16="http://schemas.microsoft.com/office/drawing/2014/main" id="{60649CF7-F4A5-4864-B5DC-FF07E317F341}"/>
              </a:ext>
            </a:extLst>
          </p:cNvPr>
          <p:cNvSpPr txBox="1"/>
          <p:nvPr/>
        </p:nvSpPr>
        <p:spPr>
          <a:xfrm>
            <a:off x="8128379" y="952433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63" name="ZoneTexte 9">
            <a:extLst>
              <a:ext uri="{FF2B5EF4-FFF2-40B4-BE49-F238E27FC236}">
                <a16:creationId xmlns:a16="http://schemas.microsoft.com/office/drawing/2014/main" id="{7FB70C4B-E63D-43D4-A5FE-3154C5F0D0E4}"/>
              </a:ext>
            </a:extLst>
          </p:cNvPr>
          <p:cNvSpPr txBox="1"/>
          <p:nvPr/>
        </p:nvSpPr>
        <p:spPr>
          <a:xfrm>
            <a:off x="8128378" y="1080257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64" name="ZoneTexte 11">
            <a:extLst>
              <a:ext uri="{FF2B5EF4-FFF2-40B4-BE49-F238E27FC236}">
                <a16:creationId xmlns:a16="http://schemas.microsoft.com/office/drawing/2014/main" id="{BE5285BB-3CB3-4AC5-88D5-D18C91D94FE2}"/>
              </a:ext>
            </a:extLst>
          </p:cNvPr>
          <p:cNvSpPr txBox="1"/>
          <p:nvPr/>
        </p:nvSpPr>
        <p:spPr>
          <a:xfrm>
            <a:off x="8118760" y="123260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65" name="ZoneTexte 14">
            <a:extLst>
              <a:ext uri="{FF2B5EF4-FFF2-40B4-BE49-F238E27FC236}">
                <a16:creationId xmlns:a16="http://schemas.microsoft.com/office/drawing/2014/main" id="{81CAAB07-5607-49EC-979B-FE9A17DE7D02}"/>
              </a:ext>
            </a:extLst>
          </p:cNvPr>
          <p:cNvSpPr txBox="1"/>
          <p:nvPr/>
        </p:nvSpPr>
        <p:spPr>
          <a:xfrm>
            <a:off x="8197307" y="202005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66" name="ZoneTexte 15">
            <a:extLst>
              <a:ext uri="{FF2B5EF4-FFF2-40B4-BE49-F238E27FC236}">
                <a16:creationId xmlns:a16="http://schemas.microsoft.com/office/drawing/2014/main" id="{F095B0E2-4EAB-4E4C-ABB8-5D651DB2FF02}"/>
              </a:ext>
            </a:extLst>
          </p:cNvPr>
          <p:cNvSpPr txBox="1"/>
          <p:nvPr/>
        </p:nvSpPr>
        <p:spPr>
          <a:xfrm>
            <a:off x="8190585" y="2283449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</p:spTree>
    <p:extLst>
      <p:ext uri="{BB962C8B-B14F-4D97-AF65-F5344CB8AC3E}">
        <p14:creationId xmlns:p14="http://schemas.microsoft.com/office/powerpoint/2010/main" val="12212498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90</Words>
  <Application>Microsoft Office PowerPoint</Application>
  <PresentationFormat>Widescreen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fil BAYAM</dc:creator>
  <cp:lastModifiedBy>Efil BAYAM</cp:lastModifiedBy>
  <cp:revision>6</cp:revision>
  <dcterms:created xsi:type="dcterms:W3CDTF">2023-10-05T09:57:30Z</dcterms:created>
  <dcterms:modified xsi:type="dcterms:W3CDTF">2024-09-09T18:02:20Z</dcterms:modified>
</cp:coreProperties>
</file>